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79D7C-DEDE-45CC-9257-6BBAF41A17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CB027C-F90D-4F5D-84E0-48C0D88C0D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186FC-40A1-49A8-9493-F37947F685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E5CF7-DCE4-4CCA-8C0B-B1580335C28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3B884-23B8-431C-99AF-D69EE5AA0B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E4230B-312F-47DD-AA42-AF54729333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BB4A30-4786-461E-A0B2-19E772AC9C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3EE24-8B8D-47F7-9130-1D07DD6125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0B71E-FF1C-42BA-B799-5189C1AC03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BC28A-A13A-48D1-A53F-9B7D145F19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428DB-408D-4028-A9DA-71D4DE8760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7AD88-22A8-4073-91BC-9D5D777E07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413147-AA65-41E4-86E7-CEE7CE08EE97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3"/>
          <p:cNvSpPr/>
          <p:nvPr/>
        </p:nvSpPr>
        <p:spPr>
          <a:xfrm>
            <a:off x="6255000" y="637524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1631880" y="1387440"/>
            <a:ext cx="5761080" cy="4033440"/>
            <a:chOff x="1631880" y="1387440"/>
            <a:chExt cx="5761080" cy="4033440"/>
          </a:xfrm>
        </p:grpSpPr>
        <p:grpSp>
          <p:nvGrpSpPr>
            <p:cNvPr id="43" name="Group 3"/>
            <p:cNvGrpSpPr/>
            <p:nvPr/>
          </p:nvGrpSpPr>
          <p:grpSpPr>
            <a:xfrm>
              <a:off x="1631880" y="3285000"/>
              <a:ext cx="5761080" cy="2074320"/>
              <a:chOff x="1631880" y="3285000"/>
              <a:chExt cx="5761080" cy="2074320"/>
            </a:xfrm>
          </p:grpSpPr>
          <p:pic>
            <p:nvPicPr>
              <p:cNvPr id="44" name="Picture 4" descr=""/>
              <p:cNvPicPr/>
              <p:nvPr/>
            </p:nvPicPr>
            <p:blipFill>
              <a:blip r:embed="rId1"/>
              <a:stretch/>
            </p:blipFill>
            <p:spPr>
              <a:xfrm>
                <a:off x="1631880" y="3285000"/>
                <a:ext cx="3057120" cy="2074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5" descr=""/>
              <p:cNvPicPr/>
              <p:nvPr/>
            </p:nvPicPr>
            <p:blipFill>
              <a:blip r:embed="rId2"/>
              <a:stretch/>
            </p:blipFill>
            <p:spPr>
              <a:xfrm>
                <a:off x="4335840" y="3285000"/>
                <a:ext cx="3057120" cy="207432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46" name="Group 6"/>
            <p:cNvGrpSpPr/>
            <p:nvPr/>
          </p:nvGrpSpPr>
          <p:grpSpPr>
            <a:xfrm>
              <a:off x="1631880" y="1387440"/>
              <a:ext cx="5761080" cy="2074320"/>
              <a:chOff x="1631880" y="1387440"/>
              <a:chExt cx="5761080" cy="2074320"/>
            </a:xfrm>
          </p:grpSpPr>
          <p:pic>
            <p:nvPicPr>
              <p:cNvPr id="47" name="Picture 7" descr=""/>
              <p:cNvPicPr/>
              <p:nvPr/>
            </p:nvPicPr>
            <p:blipFill>
              <a:blip r:embed="rId3"/>
              <a:stretch/>
            </p:blipFill>
            <p:spPr>
              <a:xfrm>
                <a:off x="1631880" y="1387440"/>
                <a:ext cx="3057120" cy="2074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8" descr=""/>
              <p:cNvPicPr/>
              <p:nvPr/>
            </p:nvPicPr>
            <p:blipFill>
              <a:blip r:embed="rId4"/>
              <a:stretch/>
            </p:blipFill>
            <p:spPr>
              <a:xfrm>
                <a:off x="4335840" y="1387440"/>
                <a:ext cx="3057120" cy="20743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49" name="Text Box 9"/>
            <p:cNvSpPr/>
            <p:nvPr/>
          </p:nvSpPr>
          <p:spPr>
            <a:xfrm>
              <a:off x="4452480" y="5113800"/>
              <a:ext cx="2772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MDA-MB-23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0"/>
            <p:cNvSpPr/>
            <p:nvPr/>
          </p:nvSpPr>
          <p:spPr>
            <a:xfrm>
              <a:off x="2153160" y="3227760"/>
              <a:ext cx="1887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MCF-7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1"/>
            <p:cNvSpPr/>
            <p:nvPr/>
          </p:nvSpPr>
          <p:spPr>
            <a:xfrm>
              <a:off x="4943880" y="3227760"/>
              <a:ext cx="1748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SKBR-3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2"/>
            <p:cNvSpPr/>
            <p:nvPr/>
          </p:nvSpPr>
          <p:spPr>
            <a:xfrm>
              <a:off x="2271240" y="5112360"/>
              <a:ext cx="1650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400" spc="-1" strike="noStrike">
                  <a:solidFill>
                    <a:srgbClr val="000000"/>
                  </a:solidFill>
                  <a:latin typeface="Arial"/>
                </a:rPr>
                <a:t>CAL5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Rectangle 15"/>
          <p:cNvSpPr/>
          <p:nvPr/>
        </p:nvSpPr>
        <p:spPr>
          <a:xfrm>
            <a:off x="1692360" y="5902200"/>
            <a:ext cx="353880" cy="119160"/>
          </a:xfrm>
          <a:prstGeom prst="rect">
            <a:avLst/>
          </a:prstGeom>
          <a:solidFill>
            <a:srgbClr val="96969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6"/>
          <p:cNvSpPr/>
          <p:nvPr/>
        </p:nvSpPr>
        <p:spPr>
          <a:xfrm>
            <a:off x="1977840" y="5805360"/>
            <a:ext cx="1686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Arial"/>
              </a:rPr>
              <a:t>Mock transfected cell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7"/>
          <p:cNvSpPr/>
          <p:nvPr/>
        </p:nvSpPr>
        <p:spPr>
          <a:xfrm>
            <a:off x="6228360" y="5805360"/>
            <a:ext cx="11865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Arial"/>
              </a:rPr>
              <a:t>Isotype contro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8"/>
          <p:cNvSpPr/>
          <p:nvPr/>
        </p:nvSpPr>
        <p:spPr>
          <a:xfrm>
            <a:off x="4127760" y="5805360"/>
            <a:ext cx="1709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Arial"/>
              </a:rPr>
              <a:t>siCD146 modified cell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0"/>
          <p:cNvSpPr/>
          <p:nvPr/>
        </p:nvSpPr>
        <p:spPr>
          <a:xfrm>
            <a:off x="5946840" y="5950080"/>
            <a:ext cx="35388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21"/>
          <p:cNvSpPr/>
          <p:nvPr/>
        </p:nvSpPr>
        <p:spPr>
          <a:xfrm>
            <a:off x="3786120" y="5891040"/>
            <a:ext cx="354240" cy="119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3"/>
          <p:cNvSpPr/>
          <p:nvPr/>
        </p:nvSpPr>
        <p:spPr>
          <a:xfrm>
            <a:off x="1978200" y="5445000"/>
            <a:ext cx="50688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24"/>
          <p:cNvSpPr/>
          <p:nvPr/>
        </p:nvSpPr>
        <p:spPr>
          <a:xfrm>
            <a:off x="4088520" y="5429160"/>
            <a:ext cx="1022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CD146 P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8"/>
          <p:cNvSpPr/>
          <p:nvPr/>
        </p:nvSpPr>
        <p:spPr>
          <a:xfrm>
            <a:off x="2327760" y="620640"/>
            <a:ext cx="4475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CD146 expression in modified cell li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8T11:08:28Z</dcterms:created>
  <dc:creator>Dr Anne marie IMBERT</dc:creator>
  <dc:description/>
  <dc:language>en-US</dc:language>
  <cp:lastModifiedBy>DSIO</cp:lastModifiedBy>
  <dcterms:modified xsi:type="dcterms:W3CDTF">2012-08-07T08:47:29Z</dcterms:modified>
  <cp:revision>11</cp:revision>
  <dc:subject/>
  <dc:title>Diapositive 1</dc:title>
</cp:coreProperties>
</file>